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77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1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93250-4A5B-44CF-8C33-95ADCF88EF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A3D5A5-A36B-4D40-A430-D03F7FD625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02B9F-D41A-4663-9F42-5C3FBA82C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399546-2DE5-4F48-A715-268F5E5BE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20706-799D-4B37-AC9D-DA21FFE8B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20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C62FE-1F30-4B25-883B-EE588F168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595DD6-7788-40D2-83A0-D48B213F56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01A26-CD94-4D8D-999E-B19D78EAC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7439B6-3789-4A48-B6AA-F4A4B0F7A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12A22-38E4-4AFF-9423-DC41ABC8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0492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8CD83C-4343-4BA5-9674-A84B0F072E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728122-E2A8-4410-8EBA-41D2766DD6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8D4F6-C40B-43CA-8F58-72FE74208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4C86B9-723F-4D7E-9FD0-1A8F5E0DE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5E67FE-FA4C-47B4-B9C9-B8AB45D98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6595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11A03-12C4-445A-975D-EEF59B0DB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8A0479-92BC-4037-A49C-901197182E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923CF-8359-4879-BB05-B2B57E41B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5A7C1-92A3-4728-B684-9601FFB21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68BE34-6F3D-442E-82EE-E23261B31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402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65C6A-9ABB-4E41-A1AF-DE544E87F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82263B-AF40-40EB-9A0C-54C26FCB08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DAD0E3-AAD3-48C1-9625-17984FBA4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AFB6D-D8A3-4BBB-A01E-6D46CD75E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81A06-EAC0-4809-9383-089929628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192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FC985-C292-4E66-B068-0E927BDFB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A57735-9894-4282-85A1-DFD6B2BF28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D8CE96-38D5-4241-A107-A365430251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0C47E5-34B0-4233-A095-77820CAE2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4268E1-D796-4FC0-9733-A0B5F3318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3BC6A3-DAE3-4006-B59D-B149B73FB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121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DD892-7B18-414C-B34F-AE6B61483D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863DF7-7FEB-442F-8AE5-D7D99C6729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BB083A-7179-4A3F-9B13-6B18EB90C6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A4BAD2-7E40-4DA4-AA56-8BA788A345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E9B4EA-92BE-49C5-BD38-41CAFA8FFE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1F88A3-9D36-4FF2-B804-9EF481156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C58B89-EDE2-41BD-9EA7-BCC7707A7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04128-3FBF-4867-8BCE-F87A21CB3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006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69CCC-DF9C-45B1-88E4-1C0EE57700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72C102-2FB4-4A91-80B2-D91C72DD0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86A355-3FD5-46CC-97C8-EFD2527C7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3DBB22-3BE4-4288-8EA7-39C858E17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78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DF58DF-9AEB-4953-A022-F963CA4B5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2DF1D1-7C45-4154-B5F5-FAD865138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D455FF-A4F3-4C0C-B680-816AC9F35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579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E290C-6291-4CCD-8B60-B9A3E7886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27195-D89B-4FDC-B2E6-ECB0455B04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4F31E8-8BD3-46F2-9E73-09205F9196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FA36AB-9AE6-4DE8-A842-0D98AB5B7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575A6B-1F5C-4E33-96DF-44F2800E9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23D1DB-0841-45DC-9E2A-B0336906C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6350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8BA38-819C-4B96-B7BC-C8D617D645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1C53D6-D8DF-40CF-8B1A-6153B63450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009045-D107-4AE2-B69C-0CC8917324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24366D-AC66-495E-B68F-E9CB27E2A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471DF-385B-4909-9F88-A77DF0A19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4DC97D-27CA-4BD9-8F3A-30E0B3CEC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479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3E5FFE-2D6D-4E02-BECE-302FA1008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077988-CAE9-4656-B476-5BF468BBB6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BC244-A6DA-4E47-BA6E-3CA517C607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6800C-F914-4028-B794-ADC61108D548}" type="datetimeFigureOut">
              <a:rPr lang="en-GB" smtClean="0"/>
              <a:t>3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6692B1-735E-4104-9AD9-CB6A95695F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B915BB-9DE9-4899-8368-8179ABAEFE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592D1-9500-4586-8EC4-685AC92D17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465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684FFA05-3F50-4AD0-A45D-AC22BBDCB5F6}"/>
              </a:ext>
            </a:extLst>
          </p:cNvPr>
          <p:cNvGrpSpPr/>
          <p:nvPr/>
        </p:nvGrpSpPr>
        <p:grpSpPr>
          <a:xfrm>
            <a:off x="705599" y="241779"/>
            <a:ext cx="10929658" cy="5489799"/>
            <a:chOff x="475930" y="23518"/>
            <a:chExt cx="10929658" cy="5489799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5B39FA3-054D-4424-86BC-CCF33113873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44395" y="23518"/>
              <a:ext cx="3561193" cy="5489799"/>
            </a:xfrm>
            <a:prstGeom prst="rect">
              <a:avLst/>
            </a:prstGeom>
          </p:spPr>
        </p:pic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DC46CC3A-F283-4A7A-B09E-7CAD88FACBE4}"/>
                </a:ext>
              </a:extLst>
            </p:cNvPr>
            <p:cNvGrpSpPr/>
            <p:nvPr/>
          </p:nvGrpSpPr>
          <p:grpSpPr>
            <a:xfrm>
              <a:off x="475930" y="1045944"/>
              <a:ext cx="3664700" cy="3444946"/>
              <a:chOff x="491972" y="2324902"/>
              <a:chExt cx="2957079" cy="2912848"/>
            </a:xfrm>
          </p:grpSpPr>
          <p:pic>
            <p:nvPicPr>
              <p:cNvPr id="4" name="Picture 3" descr="A picture containing indoor&#10;&#10;Description automatically generated">
                <a:extLst>
                  <a:ext uri="{FF2B5EF4-FFF2-40B4-BE49-F238E27FC236}">
                    <a16:creationId xmlns:a16="http://schemas.microsoft.com/office/drawing/2014/main" id="{86534CAF-9B70-46F0-BD09-48E0123041E1}"/>
                  </a:ext>
                </a:extLst>
              </p:cNvPr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839" t="7696" r="19849" b="8803"/>
              <a:stretch/>
            </p:blipFill>
            <p:spPr bwMode="auto">
              <a:xfrm rot="5400000">
                <a:off x="556491" y="2345189"/>
                <a:ext cx="2912848" cy="2872273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2003033-A9ED-4AF7-8A0F-07808FCC6E25}"/>
                  </a:ext>
                </a:extLst>
              </p:cNvPr>
              <p:cNvSpPr txBox="1"/>
              <p:nvPr/>
            </p:nvSpPr>
            <p:spPr>
              <a:xfrm>
                <a:off x="2012914" y="2820285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4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DF5A506-0823-46F4-8735-D39D18D03D12}"/>
                  </a:ext>
                </a:extLst>
              </p:cNvPr>
              <p:cNvSpPr txBox="1"/>
              <p:nvPr/>
            </p:nvSpPr>
            <p:spPr>
              <a:xfrm>
                <a:off x="1663070" y="444516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4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924891E-8EA6-474E-9892-3CA546745D05}"/>
                  </a:ext>
                </a:extLst>
              </p:cNvPr>
              <p:cNvSpPr txBox="1"/>
              <p:nvPr/>
            </p:nvSpPr>
            <p:spPr>
              <a:xfrm>
                <a:off x="1256962" y="2751134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3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A5712AA-2176-407E-B10C-16DF6E09DABA}"/>
                  </a:ext>
                </a:extLst>
              </p:cNvPr>
              <p:cNvSpPr txBox="1"/>
              <p:nvPr/>
            </p:nvSpPr>
            <p:spPr>
              <a:xfrm>
                <a:off x="1199511" y="445471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3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4E7762A-171F-4148-93C0-30211F5D16FB}"/>
                  </a:ext>
                </a:extLst>
              </p:cNvPr>
              <p:cNvSpPr txBox="1"/>
              <p:nvPr/>
            </p:nvSpPr>
            <p:spPr>
              <a:xfrm>
                <a:off x="747989" y="3012744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2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B0E076C-A00D-446D-B69E-7CE2AAD5DFED}"/>
                  </a:ext>
                </a:extLst>
              </p:cNvPr>
              <p:cNvSpPr txBox="1"/>
              <p:nvPr/>
            </p:nvSpPr>
            <p:spPr>
              <a:xfrm>
                <a:off x="908410" y="371445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5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7954228-2279-4797-B32E-6FD64051DA34}"/>
                  </a:ext>
                </a:extLst>
              </p:cNvPr>
              <p:cNvSpPr txBox="1"/>
              <p:nvPr/>
            </p:nvSpPr>
            <p:spPr>
              <a:xfrm>
                <a:off x="1699388" y="3632723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6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4E06536-2712-422B-BA64-6B7F23591734}"/>
                  </a:ext>
                </a:extLst>
              </p:cNvPr>
              <p:cNvSpPr txBox="1"/>
              <p:nvPr/>
            </p:nvSpPr>
            <p:spPr>
              <a:xfrm>
                <a:off x="2715817" y="445471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6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9EA7965-949E-4CEC-A175-A1D3B4513C76}"/>
                  </a:ext>
                </a:extLst>
              </p:cNvPr>
              <p:cNvSpPr txBox="1"/>
              <p:nvPr/>
            </p:nvSpPr>
            <p:spPr>
              <a:xfrm>
                <a:off x="2189443" y="444516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5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F62727B-C2F9-4962-AE0A-3820A54F7F5F}"/>
                  </a:ext>
                </a:extLst>
              </p:cNvPr>
              <p:cNvSpPr txBox="1"/>
              <p:nvPr/>
            </p:nvSpPr>
            <p:spPr>
              <a:xfrm>
                <a:off x="847813" y="470677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2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012F36E-DF02-424E-999B-7A43E9B2EBFF}"/>
                  </a:ext>
                </a:extLst>
              </p:cNvPr>
              <p:cNvSpPr txBox="1"/>
              <p:nvPr/>
            </p:nvSpPr>
            <p:spPr>
              <a:xfrm>
                <a:off x="491972" y="4533100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C59F5F1-47F7-4A82-A14D-543A923C2AE2}"/>
                  </a:ext>
                </a:extLst>
              </p:cNvPr>
              <p:cNvSpPr txBox="1"/>
              <p:nvPr/>
            </p:nvSpPr>
            <p:spPr>
              <a:xfrm>
                <a:off x="644251" y="2557188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1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EB7FE2EF-B66A-45FF-A701-AF5FDB10C866}"/>
                </a:ext>
              </a:extLst>
            </p:cNvPr>
            <p:cNvGrpSpPr/>
            <p:nvPr/>
          </p:nvGrpSpPr>
          <p:grpSpPr>
            <a:xfrm>
              <a:off x="4372695" y="1114871"/>
              <a:ext cx="3347395" cy="3307092"/>
              <a:chOff x="3561020" y="2426383"/>
              <a:chExt cx="2872274" cy="2723133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C3FFEF0F-27AF-44AE-9C6F-BD8FF1AA6116}"/>
                  </a:ext>
                </a:extLst>
              </p:cNvPr>
              <p:cNvPicPr/>
              <p:nvPr/>
            </p:nvPicPr>
            <p:blipFill>
              <a:blip r:embed="rId4">
                <a:alphaModFix/>
              </a:blip>
              <a:stretch>
                <a:fillRect/>
              </a:stretch>
            </p:blipFill>
            <p:spPr>
              <a:xfrm>
                <a:off x="3561020" y="2465270"/>
                <a:ext cx="2872274" cy="2684246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E7F3E89-4F43-492E-A808-128D7E5577DE}"/>
                  </a:ext>
                </a:extLst>
              </p:cNvPr>
              <p:cNvSpPr txBox="1"/>
              <p:nvPr/>
            </p:nvSpPr>
            <p:spPr>
              <a:xfrm>
                <a:off x="5077326" y="2744699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4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CFEB0B4-98B4-4DA9-A1B8-96B275820567}"/>
                  </a:ext>
                </a:extLst>
              </p:cNvPr>
              <p:cNvSpPr txBox="1"/>
              <p:nvPr/>
            </p:nvSpPr>
            <p:spPr>
              <a:xfrm>
                <a:off x="4632974" y="444516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4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A7136D8-84C3-452A-8420-3DD5371A22C6}"/>
                  </a:ext>
                </a:extLst>
              </p:cNvPr>
              <p:cNvSpPr txBox="1"/>
              <p:nvPr/>
            </p:nvSpPr>
            <p:spPr>
              <a:xfrm>
                <a:off x="4142067" y="418355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3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C5E2423-6AF9-4DE0-8AF3-B6312277985B}"/>
                  </a:ext>
                </a:extLst>
              </p:cNvPr>
              <p:cNvSpPr txBox="1"/>
              <p:nvPr/>
            </p:nvSpPr>
            <p:spPr>
              <a:xfrm>
                <a:off x="3790369" y="4435612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2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1981153-719D-41FC-AD93-9C07DAB57F2D}"/>
                  </a:ext>
                </a:extLst>
              </p:cNvPr>
              <p:cNvSpPr txBox="1"/>
              <p:nvPr/>
            </p:nvSpPr>
            <p:spPr>
              <a:xfrm>
                <a:off x="4142067" y="2426383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3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B73DCF2-3266-4954-AD78-9283F150F5FF}"/>
                  </a:ext>
                </a:extLst>
              </p:cNvPr>
              <p:cNvSpPr txBox="1"/>
              <p:nvPr/>
            </p:nvSpPr>
            <p:spPr>
              <a:xfrm>
                <a:off x="3633094" y="2687993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2</a:t>
                </a:r>
              </a:p>
            </p:txBody>
          </p:sp>
        </p:grp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D459F50B-C3C2-4A7D-94D2-741F0AD0948C}"/>
              </a:ext>
            </a:extLst>
          </p:cNvPr>
          <p:cNvSpPr txBox="1"/>
          <p:nvPr/>
        </p:nvSpPr>
        <p:spPr>
          <a:xfrm>
            <a:off x="633464" y="5621455"/>
            <a:ext cx="109541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Figure 5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Rhythms of LUC+ bioluminescence generated by half leaf explants can recapitulate those of intact detached leaves of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GB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axiflora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. </a:t>
            </a:r>
            <a:r>
              <a:rPr lang="en-GB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laxiflora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iploid OBG expressing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lGPT2p::LUC+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were imaged under LL conditions at 15˚C for ~7-d.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Plate layout for experiment, showing both intact leaves and half leaf explants of 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K. </a:t>
            </a:r>
            <a:r>
              <a:rPr lang="en-GB" sz="1200" i="1" dirty="0" err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laxiflora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expressing 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KlGPT2p::LUC+,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during preliminary experiments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LUC+ bioluminescence generated at ZT96 during imaging time course by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. </a:t>
            </a:r>
            <a:r>
              <a:rPr lang="en-GB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laxiflora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expressing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KlGPT2p::LUC+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(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C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an LUC+ expression from ZT96 – ZT166. Some of the imaging protocol was still being optimised during this experiment so this time window has been chosen for greatest clarity</a:t>
            </a: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C88F914-12A5-4E4C-9815-93D1CBF6199D}"/>
              </a:ext>
            </a:extLst>
          </p:cNvPr>
          <p:cNvSpPr txBox="1"/>
          <p:nvPr/>
        </p:nvSpPr>
        <p:spPr>
          <a:xfrm>
            <a:off x="725587" y="931070"/>
            <a:ext cx="63658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.                                                               B.                                 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418ECE5-3804-4C96-8DBF-0A4B8D1AE820}"/>
              </a:ext>
            </a:extLst>
          </p:cNvPr>
          <p:cNvSpPr txBox="1"/>
          <p:nvPr/>
        </p:nvSpPr>
        <p:spPr>
          <a:xfrm>
            <a:off x="8160488" y="179399"/>
            <a:ext cx="762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861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159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6 – comparison of intact and half Kl leaves for imaging system</dc:title>
  <dc:creator>Jessica Pritchard</dc:creator>
  <cp:lastModifiedBy>Hartwell, James</cp:lastModifiedBy>
  <cp:revision>3</cp:revision>
  <dcterms:created xsi:type="dcterms:W3CDTF">2026-03-06T17:43:12Z</dcterms:created>
  <dcterms:modified xsi:type="dcterms:W3CDTF">2026-03-31T17:17:22Z</dcterms:modified>
</cp:coreProperties>
</file>